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C5119FB-92B1-4299-A1BF-E64C4DF4B2FC}" v="6" dt="2025-11-02T22:02:37.290"/>
    <p1510:client id="{6E705E53-C5BB-48A0-B7D9-31E9C3D13C6A}" v="2" dt="2025-11-02T22:07:53.752"/>
    <p1510:client id="{833EB9B9-4D70-4D36-8C02-AB21E9A6727A}" v="2" dt="2025-11-02T22:14:59.562"/>
    <p1510:client id="{A47FBF98-B9AB-42A9-B760-7BAF5E69BB03}" v="2" dt="2025-11-02T22:11:34.589"/>
    <p1510:client id="{BFB157A3-EDF0-45F6-ABC2-3EFB301C0595}" v="3" dt="2025-11-02T21:18:48.04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90" d="100"/>
          <a:sy n="90" d="100"/>
        </p:scale>
        <p:origin x="96" y="3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obel, Raymond" userId="682ea7fd-2081-4ef7-9ccf-cc036b672067" providerId="ADAL" clId="{327064EF-D6E0-4CA7-937D-5219C7D36AD4}"/>
    <pc:docChg chg="undo custSel addSld modSld modMainMaster">
      <pc:chgData name="Sobel, Raymond" userId="682ea7fd-2081-4ef7-9ccf-cc036b672067" providerId="ADAL" clId="{327064EF-D6E0-4CA7-937D-5219C7D36AD4}" dt="2025-11-02T22:15:49.970" v="394" actId="1076"/>
      <pc:docMkLst>
        <pc:docMk/>
      </pc:docMkLst>
      <pc:sldChg chg="addSp delSp modSp new mod">
        <pc:chgData name="Sobel, Raymond" userId="682ea7fd-2081-4ef7-9ccf-cc036b672067" providerId="ADAL" clId="{327064EF-D6E0-4CA7-937D-5219C7D36AD4}" dt="2025-11-02T22:15:49.970" v="394" actId="1076"/>
        <pc:sldMkLst>
          <pc:docMk/>
          <pc:sldMk cId="3744564216" sldId="256"/>
        </pc:sldMkLst>
        <pc:spChg chg="add mod">
          <ac:chgData name="Sobel, Raymond" userId="682ea7fd-2081-4ef7-9ccf-cc036b672067" providerId="ADAL" clId="{327064EF-D6E0-4CA7-937D-5219C7D36AD4}" dt="2025-11-02T22:15:31.247" v="393" actId="6549"/>
          <ac:spMkLst>
            <pc:docMk/>
            <pc:sldMk cId="3744564216" sldId="256"/>
            <ac:spMk id="4" creationId="{2571C028-8524-3A49-B9BB-8EE9AB795E3A}"/>
          </ac:spMkLst>
        </pc:spChg>
        <pc:picChg chg="add mod">
          <ac:chgData name="Sobel, Raymond" userId="682ea7fd-2081-4ef7-9ccf-cc036b672067" providerId="ADAL" clId="{327064EF-D6E0-4CA7-937D-5219C7D36AD4}" dt="2025-11-02T22:15:49.970" v="394" actId="1076"/>
          <ac:picMkLst>
            <pc:docMk/>
            <pc:sldMk cId="3744564216" sldId="256"/>
            <ac:picMk id="3" creationId="{711C3BD2-BF01-7FBF-AF9F-CC7EF85D69BD}"/>
          </ac:picMkLst>
        </pc:picChg>
        <pc:picChg chg="add del mod">
          <ac:chgData name="Sobel, Raymond" userId="682ea7fd-2081-4ef7-9ccf-cc036b672067" providerId="ADAL" clId="{327064EF-D6E0-4CA7-937D-5219C7D36AD4}" dt="2025-11-02T21:58:20.976" v="138" actId="478"/>
          <ac:picMkLst>
            <pc:docMk/>
            <pc:sldMk cId="3744564216" sldId="256"/>
            <ac:picMk id="3" creationId="{A11ABE44-0B99-3AE0-A94A-378154AA6F58}"/>
          </ac:picMkLst>
        </pc:picChg>
        <pc:picChg chg="add del mod">
          <ac:chgData name="Sobel, Raymond" userId="682ea7fd-2081-4ef7-9ccf-cc036b672067" providerId="ADAL" clId="{327064EF-D6E0-4CA7-937D-5219C7D36AD4}" dt="2025-11-02T22:10:47.044" v="361" actId="478"/>
          <ac:picMkLst>
            <pc:docMk/>
            <pc:sldMk cId="3744564216" sldId="256"/>
            <ac:picMk id="3" creationId="{DD97DE04-0243-11C6-95A7-3A5095BC448F}"/>
          </ac:picMkLst>
        </pc:picChg>
        <pc:picChg chg="add del mod">
          <ac:chgData name="Sobel, Raymond" userId="682ea7fd-2081-4ef7-9ccf-cc036b672067" providerId="ADAL" clId="{327064EF-D6E0-4CA7-937D-5219C7D36AD4}" dt="2025-11-02T22:02:35.350" v="189" actId="22"/>
          <ac:picMkLst>
            <pc:docMk/>
            <pc:sldMk cId="3744564216" sldId="256"/>
            <ac:picMk id="5" creationId="{1C21A08C-4675-F840-2E10-62A3AB665585}"/>
          </ac:picMkLst>
        </pc:picChg>
        <pc:picChg chg="add del mod">
          <ac:chgData name="Sobel, Raymond" userId="682ea7fd-2081-4ef7-9ccf-cc036b672067" providerId="ADAL" clId="{327064EF-D6E0-4CA7-937D-5219C7D36AD4}" dt="2025-11-02T22:14:08.108" v="380" actId="478"/>
          <ac:picMkLst>
            <pc:docMk/>
            <pc:sldMk cId="3744564216" sldId="256"/>
            <ac:picMk id="5" creationId="{A144E09B-0921-1BAA-5089-C89419B14848}"/>
          </ac:picMkLst>
        </pc:picChg>
        <pc:picChg chg="add del mod">
          <ac:chgData name="Sobel, Raymond" userId="682ea7fd-2081-4ef7-9ccf-cc036b672067" providerId="ADAL" clId="{327064EF-D6E0-4CA7-937D-5219C7D36AD4}" dt="2025-11-02T22:06:59.744" v="344" actId="478"/>
          <ac:picMkLst>
            <pc:docMk/>
            <pc:sldMk cId="3744564216" sldId="256"/>
            <ac:picMk id="7" creationId="{0AF45F89-BEF0-826D-4DC4-1CCB0C890112}"/>
          </ac:picMkLst>
        </pc:picChg>
      </pc:sldChg>
      <pc:sldMasterChg chg="modSp modSldLayout">
        <pc:chgData name="Sobel, Raymond" userId="682ea7fd-2081-4ef7-9ccf-cc036b672067" providerId="ADAL" clId="{327064EF-D6E0-4CA7-937D-5219C7D36AD4}" dt="2025-11-02T22:02:37.290" v="192"/>
        <pc:sldMasterMkLst>
          <pc:docMk/>
          <pc:sldMasterMk cId="1136608070" sldId="2147483648"/>
        </pc:sldMasterMkLst>
        <pc:spChg chg="mod">
          <ac:chgData name="Sobel, Raymond" userId="682ea7fd-2081-4ef7-9ccf-cc036b672067" providerId="ADAL" clId="{327064EF-D6E0-4CA7-937D-5219C7D36AD4}" dt="2025-11-02T22:02:37.290" v="192"/>
          <ac:spMkLst>
            <pc:docMk/>
            <pc:sldMasterMk cId="1136608070" sldId="2147483648"/>
            <ac:spMk id="2" creationId="{F8EABF90-C8C6-258C-D545-2FDDE03F65EF}"/>
          </ac:spMkLst>
        </pc:spChg>
        <pc:spChg chg="mod">
          <ac:chgData name="Sobel, Raymond" userId="682ea7fd-2081-4ef7-9ccf-cc036b672067" providerId="ADAL" clId="{327064EF-D6E0-4CA7-937D-5219C7D36AD4}" dt="2025-11-02T22:02:37.290" v="192"/>
          <ac:spMkLst>
            <pc:docMk/>
            <pc:sldMasterMk cId="1136608070" sldId="2147483648"/>
            <ac:spMk id="3" creationId="{2D87894B-552E-2C03-AAEA-665D50462D31}"/>
          </ac:spMkLst>
        </pc:spChg>
        <pc:spChg chg="mod">
          <ac:chgData name="Sobel, Raymond" userId="682ea7fd-2081-4ef7-9ccf-cc036b672067" providerId="ADAL" clId="{327064EF-D6E0-4CA7-937D-5219C7D36AD4}" dt="2025-11-02T22:02:37.290" v="192"/>
          <ac:spMkLst>
            <pc:docMk/>
            <pc:sldMasterMk cId="1136608070" sldId="2147483648"/>
            <ac:spMk id="4" creationId="{D940C522-B832-62D4-48D3-4D791369137D}"/>
          </ac:spMkLst>
        </pc:spChg>
        <pc:spChg chg="mod">
          <ac:chgData name="Sobel, Raymond" userId="682ea7fd-2081-4ef7-9ccf-cc036b672067" providerId="ADAL" clId="{327064EF-D6E0-4CA7-937D-5219C7D36AD4}" dt="2025-11-02T22:02:37.290" v="192"/>
          <ac:spMkLst>
            <pc:docMk/>
            <pc:sldMasterMk cId="1136608070" sldId="2147483648"/>
            <ac:spMk id="5" creationId="{1351F338-9539-B24F-421B-DFBC140BEABB}"/>
          </ac:spMkLst>
        </pc:spChg>
        <pc:spChg chg="mod">
          <ac:chgData name="Sobel, Raymond" userId="682ea7fd-2081-4ef7-9ccf-cc036b672067" providerId="ADAL" clId="{327064EF-D6E0-4CA7-937D-5219C7D36AD4}" dt="2025-11-02T22:02:37.290" v="192"/>
          <ac:spMkLst>
            <pc:docMk/>
            <pc:sldMasterMk cId="1136608070" sldId="2147483648"/>
            <ac:spMk id="6" creationId="{2941CA7C-86C7-4830-0048-93FD2296F519}"/>
          </ac:spMkLst>
        </pc:spChg>
        <pc:sldLayoutChg chg="modSp">
          <pc:chgData name="Sobel, Raymond" userId="682ea7fd-2081-4ef7-9ccf-cc036b672067" providerId="ADAL" clId="{327064EF-D6E0-4CA7-937D-5219C7D36AD4}" dt="2025-11-02T22:02:37.290" v="192"/>
          <pc:sldLayoutMkLst>
            <pc:docMk/>
            <pc:sldMasterMk cId="1136608070" sldId="2147483648"/>
            <pc:sldLayoutMk cId="1991882961" sldId="2147483649"/>
          </pc:sldLayoutMkLst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1991882961" sldId="2147483649"/>
              <ac:spMk id="2" creationId="{FF978EDB-5F52-504E-97C6-A58E6BA224ED}"/>
            </ac:spMkLst>
          </pc:spChg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1991882961" sldId="2147483649"/>
              <ac:spMk id="3" creationId="{A316248E-A6CB-A0B5-2F06-CFE70D7386C9}"/>
            </ac:spMkLst>
          </pc:spChg>
        </pc:sldLayoutChg>
        <pc:sldLayoutChg chg="modSp">
          <pc:chgData name="Sobel, Raymond" userId="682ea7fd-2081-4ef7-9ccf-cc036b672067" providerId="ADAL" clId="{327064EF-D6E0-4CA7-937D-5219C7D36AD4}" dt="2025-11-02T22:02:37.290" v="192"/>
          <pc:sldLayoutMkLst>
            <pc:docMk/>
            <pc:sldMasterMk cId="1136608070" sldId="2147483648"/>
            <pc:sldLayoutMk cId="2876749716" sldId="2147483651"/>
          </pc:sldLayoutMkLst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2876749716" sldId="2147483651"/>
              <ac:spMk id="2" creationId="{A5E9D775-F6CC-373E-59E9-733A894CE0D5}"/>
            </ac:spMkLst>
          </pc:spChg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2876749716" sldId="2147483651"/>
              <ac:spMk id="3" creationId="{8A1B44E5-651F-69E9-3CE4-1436A256826D}"/>
            </ac:spMkLst>
          </pc:spChg>
        </pc:sldLayoutChg>
        <pc:sldLayoutChg chg="modSp">
          <pc:chgData name="Sobel, Raymond" userId="682ea7fd-2081-4ef7-9ccf-cc036b672067" providerId="ADAL" clId="{327064EF-D6E0-4CA7-937D-5219C7D36AD4}" dt="2025-11-02T22:02:37.290" v="192"/>
          <pc:sldLayoutMkLst>
            <pc:docMk/>
            <pc:sldMasterMk cId="1136608070" sldId="2147483648"/>
            <pc:sldLayoutMk cId="3159592507" sldId="2147483652"/>
          </pc:sldLayoutMkLst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3159592507" sldId="2147483652"/>
              <ac:spMk id="3" creationId="{C685A6F0-46BA-1392-9D3A-EEB8258B8684}"/>
            </ac:spMkLst>
          </pc:spChg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3159592507" sldId="2147483652"/>
              <ac:spMk id="4" creationId="{CA89A05A-1D67-3E58-E8B7-E83A7645007D}"/>
            </ac:spMkLst>
          </pc:spChg>
        </pc:sldLayoutChg>
        <pc:sldLayoutChg chg="modSp">
          <pc:chgData name="Sobel, Raymond" userId="682ea7fd-2081-4ef7-9ccf-cc036b672067" providerId="ADAL" clId="{327064EF-D6E0-4CA7-937D-5219C7D36AD4}" dt="2025-11-02T22:02:37.290" v="192"/>
          <pc:sldLayoutMkLst>
            <pc:docMk/>
            <pc:sldMasterMk cId="1136608070" sldId="2147483648"/>
            <pc:sldLayoutMk cId="2737182433" sldId="2147483653"/>
          </pc:sldLayoutMkLst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2737182433" sldId="2147483653"/>
              <ac:spMk id="2" creationId="{8708E09E-9365-5B5A-BAEC-D42176719BAF}"/>
            </ac:spMkLst>
          </pc:spChg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2737182433" sldId="2147483653"/>
              <ac:spMk id="3" creationId="{C23564CF-5010-8670-804F-CD9855723DA7}"/>
            </ac:spMkLst>
          </pc:spChg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2737182433" sldId="2147483653"/>
              <ac:spMk id="4" creationId="{65ACD0DF-19A1-CB89-074E-65A71F129AA6}"/>
            </ac:spMkLst>
          </pc:spChg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2737182433" sldId="2147483653"/>
              <ac:spMk id="5" creationId="{C8948A43-BF6C-1500-41C6-8F4C085BBB3B}"/>
            </ac:spMkLst>
          </pc:spChg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2737182433" sldId="2147483653"/>
              <ac:spMk id="6" creationId="{1B323149-969B-9BD6-94FF-9C390A1E0D6C}"/>
            </ac:spMkLst>
          </pc:spChg>
        </pc:sldLayoutChg>
        <pc:sldLayoutChg chg="modSp">
          <pc:chgData name="Sobel, Raymond" userId="682ea7fd-2081-4ef7-9ccf-cc036b672067" providerId="ADAL" clId="{327064EF-D6E0-4CA7-937D-5219C7D36AD4}" dt="2025-11-02T22:02:37.290" v="192"/>
          <pc:sldLayoutMkLst>
            <pc:docMk/>
            <pc:sldMasterMk cId="1136608070" sldId="2147483648"/>
            <pc:sldLayoutMk cId="1549421126" sldId="2147483656"/>
          </pc:sldLayoutMkLst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1549421126" sldId="2147483656"/>
              <ac:spMk id="2" creationId="{58B65CA6-DEDC-D345-87C6-2B647EF61676}"/>
            </ac:spMkLst>
          </pc:spChg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1549421126" sldId="2147483656"/>
              <ac:spMk id="3" creationId="{A234FB66-34CB-D54F-901B-463F41987112}"/>
            </ac:spMkLst>
          </pc:spChg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1549421126" sldId="2147483656"/>
              <ac:spMk id="4" creationId="{81214F8F-DC2A-0D68-95CD-23642BBBD801}"/>
            </ac:spMkLst>
          </pc:spChg>
        </pc:sldLayoutChg>
        <pc:sldLayoutChg chg="modSp">
          <pc:chgData name="Sobel, Raymond" userId="682ea7fd-2081-4ef7-9ccf-cc036b672067" providerId="ADAL" clId="{327064EF-D6E0-4CA7-937D-5219C7D36AD4}" dt="2025-11-02T22:02:37.290" v="192"/>
          <pc:sldLayoutMkLst>
            <pc:docMk/>
            <pc:sldMasterMk cId="1136608070" sldId="2147483648"/>
            <pc:sldLayoutMk cId="803478031" sldId="2147483657"/>
          </pc:sldLayoutMkLst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803478031" sldId="2147483657"/>
              <ac:spMk id="2" creationId="{F526A7AE-AB11-C684-A9BF-54A664F013FD}"/>
            </ac:spMkLst>
          </pc:spChg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803478031" sldId="2147483657"/>
              <ac:spMk id="3" creationId="{C18C5981-53C6-3AAA-2484-E58FBD5E9BA4}"/>
            </ac:spMkLst>
          </pc:spChg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803478031" sldId="2147483657"/>
              <ac:spMk id="4" creationId="{E2BFB993-6317-0FF6-AA42-9CEA85DBB75F}"/>
            </ac:spMkLst>
          </pc:spChg>
        </pc:sldLayoutChg>
        <pc:sldLayoutChg chg="modSp">
          <pc:chgData name="Sobel, Raymond" userId="682ea7fd-2081-4ef7-9ccf-cc036b672067" providerId="ADAL" clId="{327064EF-D6E0-4CA7-937D-5219C7D36AD4}" dt="2025-11-02T22:02:37.290" v="192"/>
          <pc:sldLayoutMkLst>
            <pc:docMk/>
            <pc:sldMasterMk cId="1136608070" sldId="2147483648"/>
            <pc:sldLayoutMk cId="1486859533" sldId="2147483659"/>
          </pc:sldLayoutMkLst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1486859533" sldId="2147483659"/>
              <ac:spMk id="2" creationId="{827685F6-C049-9913-DC0B-3B932D24BC30}"/>
            </ac:spMkLst>
          </pc:spChg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1486859533" sldId="2147483659"/>
              <ac:spMk id="3" creationId="{EEEB0B2C-459A-7758-7E8B-60724828F431}"/>
            </ac:spMkLst>
          </pc:spChg>
        </pc:sldLayoutChg>
      </pc:sldMaster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978EDB-5F52-504E-97C6-A58E6BA224E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4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316248E-A6CB-A0B5-2F06-CFE70D7386C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11" indent="0" algn="ctr">
              <a:buNone/>
              <a:defRPr sz="2000"/>
            </a:lvl2pPr>
            <a:lvl3pPr marL="914422" indent="0" algn="ctr">
              <a:buNone/>
              <a:defRPr sz="1801"/>
            </a:lvl3pPr>
            <a:lvl4pPr marL="1371635" indent="0" algn="ctr">
              <a:buNone/>
              <a:defRPr sz="1600"/>
            </a:lvl4pPr>
            <a:lvl5pPr marL="1828846" indent="0" algn="ctr">
              <a:buNone/>
              <a:defRPr sz="1600"/>
            </a:lvl5pPr>
            <a:lvl6pPr marL="2286057" indent="0" algn="ctr">
              <a:buNone/>
              <a:defRPr sz="1600"/>
            </a:lvl6pPr>
            <a:lvl7pPr marL="2743268" indent="0" algn="ctr">
              <a:buNone/>
              <a:defRPr sz="1600"/>
            </a:lvl7pPr>
            <a:lvl8pPr marL="3200481" indent="0" algn="ctr">
              <a:buNone/>
              <a:defRPr sz="1600"/>
            </a:lvl8pPr>
            <a:lvl9pPr marL="3657692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54AD152-6223-FC67-BF48-71CEB6A209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362267-1483-2BBD-06AC-774E5BB220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DB06AF-E14D-26ED-89A6-839AA71C26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18829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87FB7C-EFDC-AF1E-2AA6-7FD5897423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B75CE5A-5827-2D33-B031-DCF353340C9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4C5A576-779E-94CA-2733-A66E72C94C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C3DEB2-62FD-13F1-44A0-E43E7A6912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227EA6E-2FDE-2B10-3F2A-D920DD4E56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66133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27685F6-C049-9913-DC0B-3B932D24BC3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899" y="365126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EEB0B2C-459A-7758-7E8B-60724828F43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199" y="365126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99E73B-90C7-C91E-F23A-0709C3B795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FFAE5C-B99D-EB01-94EE-C1DD58D4C6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51A5F1-9906-EED8-625B-3DBE174ECC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68595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F15C59-234F-3007-C855-6DC0DCC7CD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ADFD54E-FBCC-90D1-C52E-219A14FD853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7EEAD6F-B7E7-D2EA-B3E6-0733366F1D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733E4A-D556-E858-4657-451077D83B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2E9E92D-D13C-B5B5-41BE-EC3F3BF202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68580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E9D775-F6CC-373E-59E9-733A894CE0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3" y="1709739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A1B44E5-651F-69E9-3CE4-1436A25682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3" y="4589466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11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22" indent="0">
              <a:buNone/>
              <a:defRPr sz="1801">
                <a:solidFill>
                  <a:schemeClr val="tx1">
                    <a:tint val="82000"/>
                  </a:schemeClr>
                </a:solidFill>
              </a:defRPr>
            </a:lvl3pPr>
            <a:lvl4pPr marL="1371635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46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57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68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81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92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55FF7D-AAA0-725B-F73F-16B3F54D59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4376F9-434B-1D06-34AE-67C72936CE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C3FF49B-3211-2746-B004-E3DFB41149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67497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6E1BE0-DF8B-CEC0-4E13-210724536C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685A6F0-46BA-1392-9D3A-EEB8258B868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A89A05A-1D67-3E58-E8B7-E83A7645007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171AE80-E74F-C2B9-A2F8-E5D5762A63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02D860F-C230-57C9-8AC8-A64B1E1D9A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61C2CF1-987A-1A10-D7D9-BF0AB76ABE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95925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08E09E-9365-5B5A-BAEC-D42176719B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365127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23564CF-5010-8670-804F-CD9855723D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93" y="1681164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11" indent="0">
              <a:buNone/>
              <a:defRPr sz="2000" b="1"/>
            </a:lvl2pPr>
            <a:lvl3pPr marL="914422" indent="0">
              <a:buNone/>
              <a:defRPr sz="1801" b="1"/>
            </a:lvl3pPr>
            <a:lvl4pPr marL="1371635" indent="0">
              <a:buNone/>
              <a:defRPr sz="1600" b="1"/>
            </a:lvl4pPr>
            <a:lvl5pPr marL="1828846" indent="0">
              <a:buNone/>
              <a:defRPr sz="1600" b="1"/>
            </a:lvl5pPr>
            <a:lvl6pPr marL="2286057" indent="0">
              <a:buNone/>
              <a:defRPr sz="1600" b="1"/>
            </a:lvl6pPr>
            <a:lvl7pPr marL="2743268" indent="0">
              <a:buNone/>
              <a:defRPr sz="1600" b="1"/>
            </a:lvl7pPr>
            <a:lvl8pPr marL="3200481" indent="0">
              <a:buNone/>
              <a:defRPr sz="1600" b="1"/>
            </a:lvl8pPr>
            <a:lvl9pPr marL="3657692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5ACD0DF-19A1-CB89-074E-65A71F129AA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93" y="2505076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8948A43-BF6C-1500-41C6-8F4C085BBB3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3" y="1681164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11" indent="0">
              <a:buNone/>
              <a:defRPr sz="2000" b="1"/>
            </a:lvl2pPr>
            <a:lvl3pPr marL="914422" indent="0">
              <a:buNone/>
              <a:defRPr sz="1801" b="1"/>
            </a:lvl3pPr>
            <a:lvl4pPr marL="1371635" indent="0">
              <a:buNone/>
              <a:defRPr sz="1600" b="1"/>
            </a:lvl4pPr>
            <a:lvl5pPr marL="1828846" indent="0">
              <a:buNone/>
              <a:defRPr sz="1600" b="1"/>
            </a:lvl5pPr>
            <a:lvl6pPr marL="2286057" indent="0">
              <a:buNone/>
              <a:defRPr sz="1600" b="1"/>
            </a:lvl6pPr>
            <a:lvl7pPr marL="2743268" indent="0">
              <a:buNone/>
              <a:defRPr sz="1600" b="1"/>
            </a:lvl7pPr>
            <a:lvl8pPr marL="3200481" indent="0">
              <a:buNone/>
              <a:defRPr sz="1600" b="1"/>
            </a:lvl8pPr>
            <a:lvl9pPr marL="3657692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B323149-969B-9BD6-94FF-9C390A1E0D6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3" y="2505076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2A5624B-6731-25C0-F627-7AC526064D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02E5339-9E26-AD35-1FA0-22B23F551E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36FF9A9-220E-694C-3D43-436FBCB4F9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71824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1CF4A7-74EA-B0B7-3279-4F7F806AB4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D2642C7-A43D-55C1-B0D4-AF26FBC115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ECAF761-5CF3-B0E2-8D04-A582558617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7EC4D3C-2B19-D9AE-6D0B-00C3B80D27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48754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8631BC2-3DB5-00C1-3E39-3EA84D79B8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A26FB49-24F2-76FB-4436-C83BAF79C8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857FD6B-7ED2-DE1D-1A31-274D87D875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67648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B65CA6-DEDC-D345-87C6-2B647EF616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1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234FB66-34CB-D54F-901B-463F4198711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92" y="987427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1214F8F-DC2A-0D68-95CD-23642BBBD80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1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11" indent="0">
              <a:buNone/>
              <a:defRPr sz="1401"/>
            </a:lvl2pPr>
            <a:lvl3pPr marL="914422" indent="0">
              <a:buNone/>
              <a:defRPr sz="1200"/>
            </a:lvl3pPr>
            <a:lvl4pPr marL="1371635" indent="0">
              <a:buNone/>
              <a:defRPr sz="1001"/>
            </a:lvl4pPr>
            <a:lvl5pPr marL="1828846" indent="0">
              <a:buNone/>
              <a:defRPr sz="1001"/>
            </a:lvl5pPr>
            <a:lvl6pPr marL="2286057" indent="0">
              <a:buNone/>
              <a:defRPr sz="1001"/>
            </a:lvl6pPr>
            <a:lvl7pPr marL="2743268" indent="0">
              <a:buNone/>
              <a:defRPr sz="1001"/>
            </a:lvl7pPr>
            <a:lvl8pPr marL="3200481" indent="0">
              <a:buNone/>
              <a:defRPr sz="1001"/>
            </a:lvl8pPr>
            <a:lvl9pPr marL="3657692" indent="0">
              <a:buNone/>
              <a:defRPr sz="100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B8E8DCF-BE26-1F58-67E6-F7C8B1D8D1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1E1A05B-8F0C-48A7-AF25-189B9C348F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28F1C86-B81A-97F0-9463-68727196DB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94211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26A7AE-AB11-C684-A9BF-54A664F013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1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18C5981-53C6-3AAA-2484-E58FBD5E9BA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92" y="987427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11" indent="0">
              <a:buNone/>
              <a:defRPr sz="2800"/>
            </a:lvl2pPr>
            <a:lvl3pPr marL="914422" indent="0">
              <a:buNone/>
              <a:defRPr sz="2400"/>
            </a:lvl3pPr>
            <a:lvl4pPr marL="1371635" indent="0">
              <a:buNone/>
              <a:defRPr sz="2000"/>
            </a:lvl4pPr>
            <a:lvl5pPr marL="1828846" indent="0">
              <a:buNone/>
              <a:defRPr sz="2000"/>
            </a:lvl5pPr>
            <a:lvl6pPr marL="2286057" indent="0">
              <a:buNone/>
              <a:defRPr sz="2000"/>
            </a:lvl6pPr>
            <a:lvl7pPr marL="2743268" indent="0">
              <a:buNone/>
              <a:defRPr sz="2000"/>
            </a:lvl7pPr>
            <a:lvl8pPr marL="3200481" indent="0">
              <a:buNone/>
              <a:defRPr sz="2000"/>
            </a:lvl8pPr>
            <a:lvl9pPr marL="3657692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2BFB993-6317-0FF6-AA42-9CEA85DBB75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1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11" indent="0">
              <a:buNone/>
              <a:defRPr sz="1401"/>
            </a:lvl2pPr>
            <a:lvl3pPr marL="914422" indent="0">
              <a:buNone/>
              <a:defRPr sz="1200"/>
            </a:lvl3pPr>
            <a:lvl4pPr marL="1371635" indent="0">
              <a:buNone/>
              <a:defRPr sz="1001"/>
            </a:lvl4pPr>
            <a:lvl5pPr marL="1828846" indent="0">
              <a:buNone/>
              <a:defRPr sz="1001"/>
            </a:lvl5pPr>
            <a:lvl6pPr marL="2286057" indent="0">
              <a:buNone/>
              <a:defRPr sz="1001"/>
            </a:lvl6pPr>
            <a:lvl7pPr marL="2743268" indent="0">
              <a:buNone/>
              <a:defRPr sz="1001"/>
            </a:lvl7pPr>
            <a:lvl8pPr marL="3200481" indent="0">
              <a:buNone/>
              <a:defRPr sz="1001"/>
            </a:lvl8pPr>
            <a:lvl9pPr marL="3657692" indent="0">
              <a:buNone/>
              <a:defRPr sz="100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6A1BD64-834E-2C58-636C-C93A525BB8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C34D3E0-9EC3-7CB2-D8BA-BED2A52AF5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985EC89-BCEF-D373-D4B6-046AA04049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34780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8EABF90-C8C6-258C-D545-2FDDE03F65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5" y="365127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D87894B-552E-2C03-AAEA-665D50462D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5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40C522-B832-62D4-48D3-4D791369137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1" y="6356353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51F338-9539-B24F-421B-DFBC140BEAB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5" y="6356353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41CA7C-86C7-4830-0048-93FD2296F51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1" y="6356353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66080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22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7" indent="-228607" algn="l" defTabSz="914422" rtl="0" eaLnBrk="1" latinLnBrk="0" hangingPunct="1">
        <a:lnSpc>
          <a:spcPct val="90000"/>
        </a:lnSpc>
        <a:spcBef>
          <a:spcPts val="1001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18" indent="-228607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29" indent="-228607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40" indent="-228607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2057453" indent="-228607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514664" indent="-228607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971875" indent="-228607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429086" indent="-228607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886297" indent="-228607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1pPr>
      <a:lvl2pPr marL="457211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2pPr>
      <a:lvl3pPr marL="914422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3pPr>
      <a:lvl4pPr marL="1371635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1828846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286057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743268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200481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657692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571C028-8524-3A49-B9BB-8EE9AB795E3A}"/>
              </a:ext>
            </a:extLst>
          </p:cNvPr>
          <p:cNvSpPr txBox="1"/>
          <p:nvPr/>
        </p:nvSpPr>
        <p:spPr>
          <a:xfrm>
            <a:off x="120819" y="469967"/>
            <a:ext cx="5082046" cy="50475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7. Histopathological findings in muscle biopsy from the patient h. Light microscopy analysis demonstrated: (A) low fiber size variability, some fibers containing multiple cytoplasmic vacuoles, internalized nuclei, some fibers splitting, and no increased endomysial connective tissue; (B) no granular or dotted aspect of the muscle cell membrane; (C) absence of myofibrillar disorganization and no accumulation of mitochondria in the periphery of the fibers; (D, E) no predominance of fiber type and no selective atrophy of a fiber type; (F) dystrophin labeling on vacuoles and muscle fiber membranes; (G) deposition of complement C5b-9 within vacuoles and along muscle fiber membranes; (H and I) positive labeling of p62 and LAMP-2 on autophagic vacuoles and membranes of abnormal fibers; (J) acid phosphatase activity within vacuoles. Abbreviations: C5b-9, complement membrane attack complex; DYS, dystrophin; GT, Gömöri trichrome; H&amp;E, hematoxylin and eosin; LAMP-2, lysosome-associated membrane protein 2; NADH-TR, reduced nicotinamide adenine dinucleotide dehydrogenase-tetrazolium reductase. Scale bar = 100 µm for all panels. </a:t>
            </a:r>
          </a:p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711C3BD2-BF01-7FBF-AF9F-CC7EF85D69B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2500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252578" y="137160"/>
            <a:ext cx="6549101" cy="65836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445642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e95f1b23-abaf-45ee-821d-b7ab251ab3bf}" enabled="0" method="" siteId="{e95f1b23-abaf-45ee-821d-b7ab251ab3bf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</TotalTime>
  <Words>208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obel, Raymond</dc:creator>
  <cp:lastModifiedBy>Sobel, Raymond</cp:lastModifiedBy>
  <cp:revision>1</cp:revision>
  <dcterms:created xsi:type="dcterms:W3CDTF">2025-11-02T21:18:12Z</dcterms:created>
  <dcterms:modified xsi:type="dcterms:W3CDTF">2025-11-02T22:15:52Z</dcterms:modified>
</cp:coreProperties>
</file>